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46317E0-171A-4C1A-B35A-1DA29A8BAC4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BE0DD85-0FBA-4A7D-8E41-ED4C15EEAF6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644A1EB-E1BF-48A2-99BF-D1C4D531F7A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F1C9237-CEA1-41A1-8087-ECC8E33D80E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6380F15-4FE5-4C74-B1A6-EB088A4F84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363DF1C-2692-47FF-A0C1-A0C6C9F3963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7CC4B6C-4BB9-48BE-B175-4032D694E3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B5313E-F40E-4231-8537-E3AB379E083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07F2A06-EA1B-41C7-B2D2-9409A2CACB6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9A6FD5-7A9F-4C30-A072-0EDC27B77A7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B17F38-99CE-48AE-8107-EE86B5F6862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3A8EDF5-7560-41F4-B441-DCE2CAA42E0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A7EFFC4-FAB8-4E31-AAC1-F45D377D0350}"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3657600" y="6411960"/>
            <a:ext cx="3048120" cy="2235240"/>
          </a:xfrm>
          <a:prstGeom prst="rect">
            <a:avLst/>
          </a:prstGeom>
          <a:ln w="0">
            <a:noFill/>
          </a:ln>
        </p:spPr>
      </p:pic>
      <p:pic>
        <p:nvPicPr>
          <p:cNvPr id="42" name="" descr=""/>
          <p:cNvPicPr/>
          <p:nvPr/>
        </p:nvPicPr>
        <p:blipFill>
          <a:blip r:embed="rId2"/>
          <a:stretch/>
        </p:blipFill>
        <p:spPr>
          <a:xfrm>
            <a:off x="152280" y="6589800"/>
            <a:ext cx="3276720" cy="1968480"/>
          </a:xfrm>
          <a:prstGeom prst="rect">
            <a:avLst/>
          </a:prstGeom>
          <a:ln w="0">
            <a:noFill/>
          </a:ln>
        </p:spPr>
      </p:pic>
      <p:pic>
        <p:nvPicPr>
          <p:cNvPr id="43" name="" descr=""/>
          <p:cNvPicPr/>
          <p:nvPr/>
        </p:nvPicPr>
        <p:blipFill>
          <a:blip r:embed="rId3"/>
          <a:stretch/>
        </p:blipFill>
        <p:spPr>
          <a:xfrm>
            <a:off x="152280" y="1712880"/>
            <a:ext cx="5105520" cy="4287960"/>
          </a:xfrm>
          <a:prstGeom prst="rect">
            <a:avLst/>
          </a:prstGeom>
          <a:ln w="0">
            <a:noFill/>
          </a:ln>
        </p:spPr>
      </p:pic>
      <p:sp>
        <p:nvSpPr>
          <p:cNvPr id="44" name="PlaceHolder 1"/>
          <p:cNvSpPr>
            <a:spLocks noGrp="1"/>
          </p:cNvSpPr>
          <p:nvPr>
            <p:ph type="title"/>
          </p:nvPr>
        </p:nvSpPr>
        <p:spPr>
          <a:xfrm>
            <a:off x="304920" y="228240"/>
            <a:ext cx="6324480" cy="1273320"/>
          </a:xfrm>
          <a:prstGeom prst="rect">
            <a:avLst/>
          </a:prstGeom>
          <a:noFill/>
          <a:ln w="0">
            <a:noFill/>
          </a:ln>
        </p:spPr>
        <p:txBody>
          <a:bodyPr lIns="90000" rIns="90000" tIns="46800" bIns="46800" anchor="ctr">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 Behavior: </a:t>
            </a:r>
            <a:r>
              <a:rPr b="0" lang="en-US" sz="1200" spc="-1" strike="noStrike">
                <a:solidFill>
                  <a:srgbClr val="000000"/>
                </a:solidFill>
                <a:latin typeface="Arial"/>
              </a:rPr>
              <a:t>All animals were highly habituated to the recording box, so that exposure to nove complex objects caused a general increase in the animals’ arousal. 4/5 animals showed an increase in time spent in WK with respect to SW and REM sleep during CSS (figure a), as compared to adjacent Pre and Post periods of equal length (60’). The only exception was rat 1, which showed nevertheless a marked exploratory drive, spending nearly 20% of the exposure period in direct whisker-contact with the objects (figure b). Individual object preferences were moderately varied, as indicates in the figure c.</a:t>
            </a:r>
            <a:endParaRPr b="0" lang="en-US" sz="1200" spc="-1" strike="noStrike">
              <a:solidFill>
                <a:srgbClr val="000000"/>
              </a:solidFill>
              <a:latin typeface="Times New Roman"/>
            </a:endParaRPr>
          </a:p>
        </p:txBody>
      </p:sp>
      <p:sp>
        <p:nvSpPr>
          <p:cNvPr id="45" name=""/>
          <p:cNvSpPr/>
          <p:nvPr/>
        </p:nvSpPr>
        <p:spPr>
          <a:xfrm>
            <a:off x="138600" y="1523880"/>
            <a:ext cx="3499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a:t>
            </a:r>
            <a:endParaRPr b="0" lang="en-US" sz="2400" spc="-1" strike="noStrike">
              <a:solidFill>
                <a:srgbClr val="000000"/>
              </a:solidFill>
              <a:latin typeface="Times New Roman"/>
            </a:endParaRPr>
          </a:p>
        </p:txBody>
      </p:sp>
      <p:sp>
        <p:nvSpPr>
          <p:cNvPr id="46" name=""/>
          <p:cNvSpPr/>
          <p:nvPr/>
        </p:nvSpPr>
        <p:spPr>
          <a:xfrm>
            <a:off x="154440" y="6208560"/>
            <a:ext cx="3499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t>
            </a:r>
            <a:endParaRPr b="0" lang="en-US" sz="2400" spc="-1" strike="noStrike">
              <a:solidFill>
                <a:srgbClr val="000000"/>
              </a:solidFill>
              <a:latin typeface="Times New Roman"/>
            </a:endParaRPr>
          </a:p>
        </p:txBody>
      </p:sp>
      <p:sp>
        <p:nvSpPr>
          <p:cNvPr id="47" name=""/>
          <p:cNvSpPr/>
          <p:nvPr/>
        </p:nvSpPr>
        <p:spPr>
          <a:xfrm>
            <a:off x="3381480" y="6208560"/>
            <a:ext cx="3330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c</a:t>
            </a: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3-27T01:46:11Z</dcterms:created>
  <dc:creator>Sidarta Ribeiro</dc:creator>
  <dc:description/>
  <dc:language>en-US</dc:language>
  <cp:lastModifiedBy>Liana Holmberg</cp:lastModifiedBy>
  <dcterms:modified xsi:type="dcterms:W3CDTF">2003-12-05T00:12:28Z</dcterms:modified>
  <cp:revision>86</cp:revision>
  <dc:subject/>
  <dc:title>Supplementary Material</dc:title>
</cp:coreProperties>
</file>